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AA275-A506-4D32-9734-EF27F532A7A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F8C84C-960A-4BFA-8B38-9D43976B69E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22AB6-85AB-4BEF-9E41-F641E79CFA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AE03F9-3AC9-48A4-A1BB-20C2EBD758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D1F50C-493C-4FA4-8F1E-86E6451CE0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55F2E6-E37A-4D64-93A9-747025132E9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06967-7274-4218-A4B5-7C5BD4AF953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204E5E-9B18-42C9-B2FB-E425BD02B7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553C25-35B1-4EF6-8CDB-A777D8D08C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AD0D9-B111-4788-9CCB-C4451E7C8A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53A17-26A1-4DA6-9395-93273D6057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E2009-3CD8-4F3C-BFE3-06B9A2CB1C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096797A-560E-4DEB-8A27-0B23B00AC1EC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430800" y="611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798080" y="622440"/>
            <a:ext cx="31608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PM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3971880" y="838080"/>
            <a:ext cx="2003400" cy="1270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078440" y="1825560"/>
            <a:ext cx="144360" cy="2826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581360" y="1954080"/>
            <a:ext cx="144720" cy="1540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079960" y="1112760"/>
            <a:ext cx="144360" cy="99540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583240" y="1027080"/>
            <a:ext cx="144360" cy="10810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222800" y="1854360"/>
            <a:ext cx="144360" cy="253800"/>
          </a:xfrm>
          <a:prstGeom prst="rect">
            <a:avLst/>
          </a:prstGeom>
          <a:solidFill>
            <a:srgbClr val="b2b2b2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726080" y="1974960"/>
            <a:ext cx="139680" cy="133200"/>
          </a:xfrm>
          <a:prstGeom prst="rect">
            <a:avLst/>
          </a:prstGeom>
          <a:solidFill>
            <a:srgbClr val="b2b2b2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5224320" y="1079640"/>
            <a:ext cx="144720" cy="1028520"/>
          </a:xfrm>
          <a:prstGeom prst="rect">
            <a:avLst/>
          </a:prstGeom>
          <a:solidFill>
            <a:srgbClr val="b2b2b2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727600" y="1062000"/>
            <a:ext cx="139680" cy="1046160"/>
          </a:xfrm>
          <a:prstGeom prst="rect">
            <a:avLst/>
          </a:prstGeom>
          <a:solidFill>
            <a:srgbClr val="b2b2b2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4148280" y="1730520"/>
            <a:ext cx="0" cy="950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137120" y="1730520"/>
            <a:ext cx="284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V="1">
            <a:off x="4651200" y="1889280"/>
            <a:ext cx="0" cy="64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638600" y="188928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flipV="1">
            <a:off x="5149800" y="1019160"/>
            <a:ext cx="0" cy="93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5138640" y="1019160"/>
            <a:ext cx="2880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 flipV="1">
            <a:off x="5653080" y="963720"/>
            <a:ext cx="0" cy="63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640480" y="96372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flipV="1">
            <a:off x="4292640" y="1765080"/>
            <a:ext cx="0" cy="889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2120" bIns="42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280040" y="1765440"/>
            <a:ext cx="2988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 flipV="1">
            <a:off x="4795920" y="1846080"/>
            <a:ext cx="0" cy="128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4782960" y="1846440"/>
            <a:ext cx="2880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 flipV="1">
            <a:off x="5294160" y="988920"/>
            <a:ext cx="0" cy="90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283360" y="988920"/>
            <a:ext cx="284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V="1">
            <a:off x="5797440" y="933120"/>
            <a:ext cx="0" cy="128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784840" y="93348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971880" y="838080"/>
            <a:ext cx="0" cy="1270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954600" y="210816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954600" y="185436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3954600" y="160164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954600" y="134460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954600" y="109224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3954600" y="838080"/>
            <a:ext cx="1728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3971880" y="2108160"/>
            <a:ext cx="200340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V="1">
            <a:off x="3971880" y="21078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 flipV="1">
            <a:off x="4475160" y="21078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4973760" y="21078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5477040" y="21078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5975280" y="210780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475160" y="2108160"/>
            <a:ext cx="0" cy="119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5477040" y="2108160"/>
            <a:ext cx="0" cy="11916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3971880" y="2108160"/>
            <a:ext cx="0" cy="235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5975280" y="2108160"/>
            <a:ext cx="0" cy="235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973760" y="2108160"/>
            <a:ext cx="0" cy="235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 rot="16200000">
            <a:off x="3254760" y="1327320"/>
            <a:ext cx="925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ercent. DC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3844800" y="204156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3821040" y="179712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3821040" y="15508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821040" y="130644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3821040" y="10587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3797640" y="814320"/>
            <a:ext cx="146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4132440" y="2181240"/>
            <a:ext cx="137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4572720" y="2181240"/>
            <a:ext cx="27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IP 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5138640" y="2181240"/>
            <a:ext cx="137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5580720" y="2181240"/>
            <a:ext cx="27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IP 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4141440" y="2306520"/>
            <a:ext cx="65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odosom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5047200" y="2306520"/>
            <a:ext cx="805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cal contac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9" name=""/>
          <p:cNvGrpSpPr/>
          <p:nvPr/>
        </p:nvGrpSpPr>
        <p:grpSpPr>
          <a:xfrm>
            <a:off x="4292640" y="838080"/>
            <a:ext cx="575280" cy="391680"/>
            <a:chOff x="4292640" y="838080"/>
            <a:chExt cx="575280" cy="391680"/>
          </a:xfrm>
        </p:grpSpPr>
        <p:sp>
          <p:nvSpPr>
            <p:cNvPr id="100" name=""/>
            <p:cNvSpPr/>
            <p:nvPr/>
          </p:nvSpPr>
          <p:spPr>
            <a:xfrm>
              <a:off x="4292640" y="838080"/>
              <a:ext cx="575280" cy="39168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354920" y="907920"/>
              <a:ext cx="93240" cy="65520"/>
            </a:xfrm>
            <a:prstGeom prst="rect">
              <a:avLst/>
            </a:prstGeom>
            <a:solidFill>
              <a:srgbClr val="00000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497120" y="865440"/>
              <a:ext cx="1789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Un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354920" y="1103760"/>
              <a:ext cx="93240" cy="65520"/>
            </a:xfrm>
            <a:prstGeom prst="rect">
              <a:avLst/>
            </a:prstGeom>
            <a:solidFill>
              <a:srgbClr val="c0c0c0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720" bIns="18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496040" y="1061280"/>
              <a:ext cx="2430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</a:rPr>
                <a:t>Wort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5" name=""/>
          <p:cNvSpPr/>
          <p:nvPr/>
        </p:nvSpPr>
        <p:spPr>
          <a:xfrm>
            <a:off x="478080" y="611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1509480" y="622440"/>
            <a:ext cx="10353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PMI + 10 % FC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1216080" y="2178000"/>
            <a:ext cx="137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656360" y="2178000"/>
            <a:ext cx="27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IP 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2260440" y="2178000"/>
            <a:ext cx="137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2702520" y="2178000"/>
            <a:ext cx="27504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700" spc="-1" strike="noStrike">
                <a:solidFill>
                  <a:srgbClr val="000000"/>
                </a:solidFill>
                <a:latin typeface="Arial"/>
              </a:rPr>
              <a:t>WIP -/-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225440" y="2303640"/>
            <a:ext cx="651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odosom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2169360" y="2303640"/>
            <a:ext cx="8053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Focal contact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 rot="16200000">
            <a:off x="317880" y="1344240"/>
            <a:ext cx="893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Percent. DC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892080" y="2043000"/>
            <a:ext cx="4932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868320" y="17985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868320" y="155268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868320" y="130824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868320" y="1060560"/>
            <a:ext cx="982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844920" y="816120"/>
            <a:ext cx="146880" cy="10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7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022400" y="849240"/>
            <a:ext cx="2081160" cy="1266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1133640" y="1089000"/>
            <a:ext cx="150480" cy="10270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655640" y="1924200"/>
            <a:ext cx="150840" cy="19188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174760" y="1871640"/>
            <a:ext cx="149400" cy="2444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2695680" y="1025640"/>
            <a:ext cx="150840" cy="1090440"/>
          </a:xfrm>
          <a:prstGeom prst="rect">
            <a:avLst/>
          </a:prstGeom>
          <a:solidFill>
            <a:srgbClr val="00000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1284120" y="1727280"/>
            <a:ext cx="149400" cy="38880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806480" y="1957320"/>
            <a:ext cx="144720" cy="15876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324160" y="1225440"/>
            <a:ext cx="149040" cy="89064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846520" y="982800"/>
            <a:ext cx="144360" cy="1133280"/>
          </a:xfrm>
          <a:prstGeom prst="rect">
            <a:avLst/>
          </a:prstGeom>
          <a:solidFill>
            <a:srgbClr val="c0c0c0"/>
          </a:solidFill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 flipV="1">
            <a:off x="1206360" y="985320"/>
            <a:ext cx="0" cy="103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193760" y="98568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 flipV="1">
            <a:off x="1728720" y="1833480"/>
            <a:ext cx="0" cy="90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716120" y="183348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 flipV="1">
            <a:off x="2246400" y="1773000"/>
            <a:ext cx="0" cy="982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2233440" y="177336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 flipV="1">
            <a:off x="2768760" y="921960"/>
            <a:ext cx="0" cy="1033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2755800" y="92232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flipV="1">
            <a:off x="1357200" y="1628640"/>
            <a:ext cx="0" cy="986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344600" y="1628640"/>
            <a:ext cx="284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 flipV="1">
            <a:off x="1879560" y="1837800"/>
            <a:ext cx="0" cy="1191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865160" y="183816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 flipV="1">
            <a:off x="2397240" y="1149120"/>
            <a:ext cx="0" cy="759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160" bIns="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2384280" y="1149480"/>
            <a:ext cx="3024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 flipV="1">
            <a:off x="2919240" y="887040"/>
            <a:ext cx="0" cy="954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2906640" y="887400"/>
            <a:ext cx="28800" cy="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022400" y="849240"/>
            <a:ext cx="0" cy="12668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006560" y="211608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006560" y="186372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006560" y="16113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006560" y="135396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006560" y="110160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006560" y="849240"/>
            <a:ext cx="1584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022400" y="2116080"/>
            <a:ext cx="2081160" cy="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 flipV="1">
            <a:off x="1022400" y="211572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 flipV="1">
            <a:off x="1544760" y="211572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2062080" y="211572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2584440" y="211572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3103560" y="2115720"/>
            <a:ext cx="0" cy="1764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544760" y="2116080"/>
            <a:ext cx="0" cy="120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584440" y="2116080"/>
            <a:ext cx="0" cy="12060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022400" y="2116080"/>
            <a:ext cx="0" cy="235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3103560" y="2116080"/>
            <a:ext cx="0" cy="235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062080" y="2116080"/>
            <a:ext cx="0" cy="235080"/>
          </a:xfrm>
          <a:prstGeom prst="line">
            <a:avLst/>
          </a:prstGeom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141560" y="804960"/>
            <a:ext cx="29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 flipV="1">
            <a:off x="1168560" y="941040"/>
            <a:ext cx="0" cy="7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168560" y="94140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1384200" y="941400"/>
            <a:ext cx="0" cy="57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554120" y="849240"/>
            <a:ext cx="576360" cy="392040"/>
          </a:xfrm>
          <a:prstGeom prst="rect">
            <a:avLst/>
          </a:prstGeom>
          <a:solidFill>
            <a:srgbClr val="ffffff"/>
          </a:solidFill>
          <a:ln w="0">
            <a:solidFill>
              <a:srgbClr val="000000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1616040" y="919080"/>
            <a:ext cx="95400" cy="6516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1759320" y="878040"/>
            <a:ext cx="17892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Un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616040" y="1116000"/>
            <a:ext cx="95400" cy="65160"/>
          </a:xfrm>
          <a:prstGeom prst="rect">
            <a:avLst/>
          </a:prstGeom>
          <a:solidFill>
            <a:srgbClr val="c0c0c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759680" y="1073160"/>
            <a:ext cx="2430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Wor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183040" y="841320"/>
            <a:ext cx="29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 flipV="1">
            <a:off x="2430360" y="977400"/>
            <a:ext cx="0" cy="73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 flipH="1">
            <a:off x="2214360" y="977760"/>
            <a:ext cx="215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2214720" y="977760"/>
            <a:ext cx="0" cy="576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2034360" y="838188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89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26T11:55:47Z</dcterms:created>
  <dc:creator>Yolanda</dc:creator>
  <dc:description/>
  <dc:language>en-US</dc:language>
  <cp:lastModifiedBy>Yolanda</cp:lastModifiedBy>
  <dcterms:modified xsi:type="dcterms:W3CDTF">2013-12-29T23:27:07Z</dcterms:modified>
  <cp:revision>360</cp:revision>
  <dc:subject/>
  <dc:title>Slide 1</dc:title>
</cp:coreProperties>
</file>